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2"/>
  </p:notesMasterIdLst>
  <p:sldIdLst>
    <p:sldId id="257" r:id="rId2"/>
    <p:sldId id="258" r:id="rId3"/>
    <p:sldId id="256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60" y="2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ableStyles" Target="tableStyle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22407C-204A-44A5-A72C-FF73DB715963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35D1CB-5552-4EDA-8D81-12D18610D19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16690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0.04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835D1CB-5552-4EDA-8D81-12D18610D19F}" type="slidenum">
              <a:rPr lang="zh-CN" altLang="en-US" smtClean="0"/>
              <a:t>1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10530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4414EF-D33F-0BC6-398A-4EA7CC755B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B4D7B30-8957-D659-8C22-16F3AA2383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A27D580-7F10-DC41-BE6A-24BE3210CF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273D6A-464B-5E46-72DF-829C7D3AC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69F250C-47E2-31BE-57CB-918229E91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336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57FC45-2974-18D2-BA5B-822D609F39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57435F6-4898-8D32-92E0-637CA08E9D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201035-10E5-35CB-A2E0-B46573197C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B812C4-8656-6EB4-83AD-2130954497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D297206-6E91-9F56-8F35-102D9EFD1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0708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A1311211-7AFF-81B7-FE91-BEAD2FBB83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DFB7F7E-E2CE-A35F-2588-AB3E52B15F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A513405-6FAB-4916-50C9-1DBAFAC69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389193-F77B-28DF-FF61-C47EC9B62C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F0699FA-3DF1-FD73-A5B5-C6DFE4A20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0174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EE1C5D4-10F6-2BCC-02AF-E936F648A6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4527CA6-61D5-BFF6-C4CD-2E09A84A00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F26C9DD-D6B0-CB67-9EF7-0736BF2516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D2C982-DAF9-9A6F-FDA3-75E5D359D3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0A2D9B-8312-3418-C944-3929F8983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87671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42B1991-9362-3B2E-C714-844B5E09E8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3E3A93A-7E4F-72C4-8D22-5FA9849AB8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A2E3B6-B7DF-3DE0-56C7-C0A8DFD6F4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08C38AC-15F7-427A-60FC-C566E3DA58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52DDFDF-3A4D-6927-5F9A-15E24A54E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73145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D1F4602-6DDF-75B9-5192-A9C572A737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D282B2-9249-8E04-A1F4-9235A8AA931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BF8B976-61CB-5719-DEDE-DC85470CE5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B9DA573-4250-2A04-F482-7711BCCE2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BFD9983-CC41-DDA4-7DF9-8C02BD4F3E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7BC95AF-7858-ADD7-A0F6-3FD08926D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1420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684540-E93E-54DA-5C19-760F17C8D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36AB3F1-8E55-5A38-068D-7BACCE2B81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7F4D68D4-59FF-0B22-3384-1978932E90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FD50C41-0F30-02B2-8A39-3A38590E9D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1B65F75-9D32-C724-5A64-D3B81E893B7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461AC57-9D93-4F0B-8127-BEB896138B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6026E1B-321C-BBF8-9EE5-78A719783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AE3E6D5-BBD3-66E7-FE65-F5FAC5F31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0819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FA0BAD-D034-EA10-A4DB-B86E5460A1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8FBAEA63-AA53-7612-6BF4-B2531B1A9C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889FC4D-67D9-07C1-09ED-2FF873C8A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73DCC34-9527-4589-CC2C-C2329BF073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08474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34B08C3-0C7E-64C2-0D66-59C4CD6286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C41214D7-8115-8BA8-5D33-CF1E64F0E7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CEB8A1A-CFAC-F141-1004-C25F25F86B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9019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B04364F-E9A5-E804-5226-79CE7BA339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68E7322-04C6-A90C-E17A-F8313F3065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8F6747D-0579-0B05-6D99-940B97495E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C0C8726-37FD-A8D8-BB47-54BD6649E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05F48B-1D74-866E-E6F8-4FB5543854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537158-F202-DC90-DDCB-2E8C7F9112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55312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5798862-1EA8-16AF-9482-0EAD6ECB7F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CFC082A-2C50-815E-B52F-CC8C689640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A894219-4AFE-DA5B-AC90-B410EA99E6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007AD7-2DBC-36B0-2536-85E299BA7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3A4CC89-5E9B-62F6-B985-B6BF1937F1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ADF69BF-FC9A-AC29-C461-09D91EBA47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2471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EBD86A6-B4DC-64F6-58A4-81C36FD586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C2D79F4-803C-560B-E484-DD5C084E68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797C2C9-4E6F-BFC5-2A34-662DB7FF1B8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8AF77-1300-487C-A2AE-00D390F74BC9}" type="datetimeFigureOut">
              <a:rPr lang="zh-CN" altLang="en-US" smtClean="0"/>
              <a:t>2025/11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1A449C-8EC7-6B8C-8125-5970529DBA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0D16E7-54A7-378A-841E-1E5D98F994E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815018-EDEB-439C-AE96-E503302889B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9603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3.png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944B140C-B703-52EB-0FFA-31197BB325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4928" y="0"/>
            <a:ext cx="928214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20240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A69D6D1-8C40-995C-A8B0-19F741390E4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7877" y="0"/>
            <a:ext cx="933624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7383123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BEB7CD8-9E10-E999-D7F5-1C12BF8CC6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2028" y="138918"/>
            <a:ext cx="9177693" cy="67190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905106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69537F3B-D450-CC47-FA4A-E2B11A7894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1603" y="0"/>
            <a:ext cx="9268794" cy="685800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1EB7F65D-EB3C-E740-8716-548D46D994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506336" y="6525729"/>
            <a:ext cx="333375" cy="20002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F2D835FB-E05E-7242-296D-FCC68D61A006}"/>
              </a:ext>
            </a:extLst>
          </p:cNvPr>
          <p:cNvSpPr txBox="1"/>
          <p:nvPr/>
        </p:nvSpPr>
        <p:spPr>
          <a:xfrm>
            <a:off x="10425695" y="6448755"/>
            <a:ext cx="71871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150" b="0" i="0" u="none" strike="noStrike" kern="1200" cap="none" spc="0" normalizeH="0" baseline="0" noProof="0" dirty="0">
                <a:ln>
                  <a:noFill/>
                </a:ln>
                <a:solidFill>
                  <a:schemeClr val="bg2">
                    <a:lumMod val="50000"/>
                  </a:schemeClr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0.04</a:t>
            </a:r>
            <a:endParaRPr kumimoji="0" lang="zh-CN" altLang="en-US" sz="1150" b="0" i="0" u="none" strike="noStrike" kern="1200" cap="none" spc="0" normalizeH="0" baseline="0" noProof="0" dirty="0">
              <a:ln>
                <a:noFill/>
              </a:ln>
              <a:solidFill>
                <a:schemeClr val="bg2">
                  <a:lumMod val="50000"/>
                </a:schemeClr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0225352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80CCB7-419D-7B8A-EA84-CDB4A0294EC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41B5CE3-37E6-D488-2244-A775CF4BBF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6099" y="0"/>
            <a:ext cx="927980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897894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DE277C-E734-445A-9B56-C442AF4A3D8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F1CCFCE-820B-CFB3-3992-AE6430E2546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1603" y="0"/>
            <a:ext cx="926879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093670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497EE1-E9BC-E87C-1521-D09F4946FCC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0C1E7AA-71DE-C898-5B8D-EC68FFFF2B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3737" y="0"/>
            <a:ext cx="9344526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0622610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A78D62A-55C8-DB52-A933-1F2B3611BF4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E80A644-19F2-25C1-A4BB-94906D4C552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0242" y="0"/>
            <a:ext cx="927151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6290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6DA1EF5-0968-CD56-DF5F-B2ED36B888B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52EEDCD-26ED-D84F-41D4-14A1DAEC39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82436" y="0"/>
            <a:ext cx="922712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111875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445ED80-1CDD-CA94-029A-CA274FF9D31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0AF619C-F536-BDE7-A95E-FD741F0073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9624" y="0"/>
            <a:ext cx="933275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724290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C72CFD-E215-D42D-0A12-603034B8D7C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D36BA4B8-8F07-7186-2C8E-E7F791426A8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1577" y="0"/>
            <a:ext cx="932884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45704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7A64917-AC24-E829-3A42-11420E4AA7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5205" y="0"/>
            <a:ext cx="9301590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5341978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7DAAFBE-0A6D-09E9-6C1A-E417FA23389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4F2AB2B-1209-9FB1-2CCF-A33812DB49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5213" y="0"/>
            <a:ext cx="9241573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63530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F36854C7-E5EA-B729-C8F4-794805F150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7231" y="0"/>
            <a:ext cx="929753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25973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D058D4C-6F1E-2D11-CCC3-75DB4F99D6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7930" y="0"/>
            <a:ext cx="927613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244529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28274CFA-00B1-DB9D-E2C7-C67646ECE8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9890" y="0"/>
            <a:ext cx="9292219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2412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8A34793-3C29-F7F2-1BF0-E49D9F91131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2557" y="0"/>
            <a:ext cx="9366885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519390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F10DD15-C4E7-1930-4BDF-17AA772D77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6549" y="0"/>
            <a:ext cx="9378902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125512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82FE581-D089-DF23-A0D9-4BB2BB6668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7866" y="184058"/>
            <a:ext cx="9107440" cy="66739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939596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91AB95C2-574D-2CF5-D0B7-4D0E1D8AC3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51083" y="0"/>
            <a:ext cx="928983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6929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3</Words>
  <Application>Microsoft Office PowerPoint</Application>
  <PresentationFormat>宽屏</PresentationFormat>
  <Paragraphs>3</Paragraphs>
  <Slides>20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4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xiaoli</dc:creator>
  <cp:lastModifiedBy>lixiaoli</cp:lastModifiedBy>
  <cp:revision>4</cp:revision>
  <dcterms:created xsi:type="dcterms:W3CDTF">2025-11-24T08:54:16Z</dcterms:created>
  <dcterms:modified xsi:type="dcterms:W3CDTF">2025-11-24T09:43:19Z</dcterms:modified>
</cp:coreProperties>
</file>